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88E8C3-EBF7-4C05-BDE8-6AADAF7AD75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215EEC-4B42-4B5C-A3AC-7BDC71FECB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B26A50-2A35-469D-8B79-85E62393D1D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BA0A06-673B-40D3-A5F1-55D40E551C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564C94-38E1-44FF-969A-A52B334804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8DC039-5F06-4FAE-A1D9-EA8706092A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0886FC-8B4B-4DE5-B2EF-6C93A46A96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96D467-B3E0-4717-AAF0-714CCC651E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08741E-4560-4182-AC1E-969E018AE1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CEF38E-187C-42F6-BEEF-856EA50D6F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A2316-FBED-483A-8B98-BC844486DE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13D390-6DC3-447D-85DC-F8693528E6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7F4217-F1B6-4761-9F77-2EEA16420D8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58680" y="285840"/>
            <a:ext cx="8058240" cy="33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15000"/>
              </a:lnSpc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4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SimSun"/>
              </a:rPr>
              <a:t>. Bias plots for MAQC data using transcript level expression summaries (procedure 1).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285840" y="1214280"/>
            <a:ext cx="8458200" cy="4923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06T17:21:46Z</dcterms:created>
  <dc:creator>Wei Zheng</dc:creator>
  <dc:description/>
  <dc:language>en-US</dc:language>
  <cp:lastModifiedBy>Wei Zheng</cp:lastModifiedBy>
  <dcterms:modified xsi:type="dcterms:W3CDTF">2011-06-06T17:25:03Z</dcterms:modified>
  <cp:revision>2</cp:revision>
  <dc:subject/>
  <dc:title>Slide 1</dc:title>
</cp:coreProperties>
</file>